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8"/>
    <p:restoredTop sz="94666"/>
  </p:normalViewPr>
  <p:slideViewPr>
    <p:cSldViewPr snapToGrid="0" snapToObjects="1" showGuides="1">
      <p:cViewPr varScale="1">
        <p:scale>
          <a:sx n="81" d="100"/>
          <a:sy n="81" d="100"/>
        </p:scale>
        <p:origin x="2552" y="19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E8AB3-3AC9-1E4A-9D96-7CEBEA9D432B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C723D1-8B3F-DB4A-A156-4BEC35DEE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74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E8AB3-3AC9-1E4A-9D96-7CEBEA9D432B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C723D1-8B3F-DB4A-A156-4BEC35DEE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10883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E8AB3-3AC9-1E4A-9D96-7CEBEA9D432B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C723D1-8B3F-DB4A-A156-4BEC35DEE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786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E8AB3-3AC9-1E4A-9D96-7CEBEA9D432B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C723D1-8B3F-DB4A-A156-4BEC35DEE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766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E8AB3-3AC9-1E4A-9D96-7CEBEA9D432B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C723D1-8B3F-DB4A-A156-4BEC35DEE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3238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E8AB3-3AC9-1E4A-9D96-7CEBEA9D432B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C723D1-8B3F-DB4A-A156-4BEC35DEE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6230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E8AB3-3AC9-1E4A-9D96-7CEBEA9D432B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C723D1-8B3F-DB4A-A156-4BEC35DEE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658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E8AB3-3AC9-1E4A-9D96-7CEBEA9D432B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C723D1-8B3F-DB4A-A156-4BEC35DEE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8376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E8AB3-3AC9-1E4A-9D96-7CEBEA9D432B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C723D1-8B3F-DB4A-A156-4BEC35DEE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409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E8AB3-3AC9-1E4A-9D96-7CEBEA9D432B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C723D1-8B3F-DB4A-A156-4BEC35DEE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3216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E8AB3-3AC9-1E4A-9D96-7CEBEA9D432B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C723D1-8B3F-DB4A-A156-4BEC35DEE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468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0E8AB3-3AC9-1E4A-9D96-7CEBEA9D432B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C723D1-8B3F-DB4A-A156-4BEC35DEE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80790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2561" r="47861" b="5346"/>
          <a:stretch/>
        </p:blipFill>
        <p:spPr>
          <a:xfrm>
            <a:off x="2420112" y="1407002"/>
            <a:ext cx="1828800" cy="173736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 rot="16200000">
            <a:off x="1978583" y="2054174"/>
            <a:ext cx="87716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smtClean="0">
                <a:latin typeface="Arial" charset="0"/>
                <a:ea typeface="Arial" charset="0"/>
                <a:cs typeface="Arial" charset="0"/>
              </a:rPr>
              <a:t>Normalized to mode</a:t>
            </a:r>
            <a:endParaRPr lang="en-US" sz="6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266759" y="3136777"/>
            <a:ext cx="4122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smtClean="0">
                <a:latin typeface="Arial" charset="0"/>
                <a:ea typeface="Arial" charset="0"/>
                <a:cs typeface="Arial" charset="0"/>
              </a:rPr>
              <a:t>FITC</a:t>
            </a:r>
            <a:endParaRPr lang="en-US" sz="8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704178" y="1430886"/>
            <a:ext cx="5533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375W</a:t>
            </a:r>
            <a:endParaRPr lang="en-US" sz="11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4273561" y="1456741"/>
            <a:ext cx="913926" cy="367844"/>
            <a:chOff x="5392177" y="3899713"/>
            <a:chExt cx="913926" cy="367844"/>
          </a:xfrm>
        </p:grpSpPr>
        <p:cxnSp>
          <p:nvCxnSpPr>
            <p:cNvPr id="7" name="Straight Connector 6"/>
            <p:cNvCxnSpPr/>
            <p:nvPr/>
          </p:nvCxnSpPr>
          <p:spPr>
            <a:xfrm>
              <a:off x="5471690" y="4003084"/>
              <a:ext cx="310101" cy="0"/>
            </a:xfrm>
            <a:prstGeom prst="line">
              <a:avLst/>
            </a:prstGeom>
            <a:ln w="12700">
              <a:solidFill>
                <a:srgbClr val="FF2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/>
            <p:cNvCxnSpPr/>
            <p:nvPr/>
          </p:nvCxnSpPr>
          <p:spPr>
            <a:xfrm>
              <a:off x="5471690" y="4155484"/>
              <a:ext cx="310101" cy="0"/>
            </a:xfrm>
            <a:prstGeom prst="line">
              <a:avLst/>
            </a:prstGeom>
            <a:ln w="12700">
              <a:solidFill>
                <a:srgbClr val="8C40E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5805645" y="3899713"/>
              <a:ext cx="47481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-sCD4</a:t>
              </a:r>
              <a:endParaRPr lang="en-US" sz="80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805645" y="4052113"/>
              <a:ext cx="5004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charset="0"/>
                  <a:ea typeface="Arial" charset="0"/>
                  <a:cs typeface="Arial" charset="0"/>
                </a:rPr>
                <a:t>+sCD4</a:t>
              </a:r>
              <a:endParaRPr lang="en-US" sz="8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5392177" y="3915620"/>
              <a:ext cx="898497" cy="333955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3" name="Rectangle 12"/>
          <p:cNvSpPr/>
          <p:nvPr/>
        </p:nvSpPr>
        <p:spPr>
          <a:xfrm>
            <a:off x="1289050" y="3720175"/>
            <a:ext cx="47244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S4 Figure. Soluble CD4 abrogates the trimer apex V2q epitope on LN8 S375W envelope. 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1229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5</Words>
  <Application>Microsoft Macintosh PowerPoint</Application>
  <PresentationFormat>Letter Paper (8.5x11 in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2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apham, Paul</dc:creator>
  <cp:lastModifiedBy>Clapham, Paul</cp:lastModifiedBy>
  <cp:revision>1</cp:revision>
  <dcterms:created xsi:type="dcterms:W3CDTF">2016-10-13T18:44:35Z</dcterms:created>
  <dcterms:modified xsi:type="dcterms:W3CDTF">2016-10-13T18:45:16Z</dcterms:modified>
</cp:coreProperties>
</file>